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1A2E568-2CBB-35D1-DE09-BADE787DA4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15B8089B-39E6-9FEA-953A-02F03470FF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F3B6FB7-8336-83DA-D770-91284BF14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E59921C-D5F3-08FF-058A-243DAEDD2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ABBF6329-B562-0AF2-6CF1-842B92DC4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30025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82486CF-0EC9-3611-528A-959B06FAE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1DA82216-F3CD-8574-B50E-A029B9D080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62A34C2-DE50-6EA4-3536-A99B5E75A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F3184AE-DB21-FC66-0C03-78EDB96B6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EAA679E-6832-076A-22F5-AB863C137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52539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1F2AB4BE-7AA8-ED90-0F39-0C65556318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D84AB977-0F82-E7AC-48F2-508FA90929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6BAEE9C-AE3D-1AD0-157E-1B04D7C70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7B8C8F7B-7506-B954-E7A5-420DDFF27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E4B19DD-F634-EDFB-E6B6-7E4C986B0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59188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1DCC1CA-9736-ACAB-3977-D9387B03D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10210137-6DC9-370A-DC9A-414D0E4119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0288404-ECB6-F703-49D3-C7655823D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4835869C-C0D9-C0C6-B51F-17F81AED04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885F29CD-92BF-ADAE-6961-9D14711D4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7249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AA42BCE-8E39-EFC7-3B89-EF0EB1578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4D16C9D5-6ED6-EAD2-826B-B23100DAA5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7A889AC-AD32-4BDF-F777-02F87DE86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B49A83A-08A0-5466-17AB-874B80E1E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AB7F75A4-BB68-5CD4-721C-B6C78F0BE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5837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18A2818-BBCB-799B-79CE-DEDB095569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C18F9B13-93EC-A407-80AE-AC1B40342C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E8B9F0B2-D029-9504-8AEB-D9C2568CE8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7013BDC3-E2F7-A031-E007-32354C1CE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11F44125-031A-C4AC-BF0D-1968E0BB5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E59C3F91-959D-6A16-F9D8-7CEF4A2A5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25885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EB85E97-CE38-0418-BA46-381458CE7A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EA426A7A-7338-DECE-6DBF-4110A6B23D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61AE28B0-76B1-4805-8A02-C3B6AF0A4F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954653BA-7650-5389-BF67-4E51F2D043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E5A627A8-D822-3B9D-18DA-20205AB2D8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0EA095C4-729B-C0DF-9AE3-4727954CDE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581E8F3D-EE9C-0FAF-0C0F-E1E4FE539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1FD50C47-DD0E-BEB6-48BA-954D150FB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11759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660FE4F-688C-437C-DBC3-30CE65E269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2777D406-A06A-E4B6-7637-55427EE09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ADED35D5-5F38-5BF9-3DB2-90037BB048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0F273A00-BC54-9083-E729-9C7E6FB63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25675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B69E585C-5D33-780B-398A-DFF3BE8D0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C0A166AF-3154-6875-2B90-4EB5A1ED8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E62A022D-E173-F87E-4CBE-03812CB71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97337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FE22C36-6DD9-684C-093F-A9B9A77BEF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3693B400-633D-EE25-5F9E-4B752B9D33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E93C71AA-3CE5-BF3C-D73E-E04F307B36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4E14C61E-E671-CC4A-0A9A-BA66F53AA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B2E7D68D-3797-4B1D-75A8-F83B5474D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D351DCD4-82F5-93A5-B12A-CEC71BE1C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89727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99D6F37-6D1A-25BA-CEA9-89C9AB543C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5B135E76-3982-B09F-30C7-ED751B0A90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1AA17D92-E3FA-CEBF-9336-BD70F4026B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1F299416-D412-D907-2937-2A7C84BD8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F6118D49-6450-CB44-B988-6AF880D9C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51975AC4-209A-1E2C-5CBE-2B962D1CD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37343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910E4CED-6D5C-64D4-2F28-27F4F6D42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8F547041-1FD1-54DD-39F1-80BBA3CCA0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8A5EA1F9-B89C-8113-FF3B-05B8FEAA2F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EFB20-18A5-4DA1-8EE0-DF0E7A311620}" type="datetimeFigureOut">
              <a:rPr lang="sv-SE" smtClean="0"/>
              <a:t>2024-11-20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B252C93-5732-E4BD-827B-158B911DC4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7E26B18-B32E-BD47-E5D7-C391807A5E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14D4A-30B6-4E49-BC73-F38C1A35F367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66594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ruta 1">
            <a:extLst>
              <a:ext uri="{FF2B5EF4-FFF2-40B4-BE49-F238E27FC236}">
                <a16:creationId xmlns:a16="http://schemas.microsoft.com/office/drawing/2014/main" id="{2D1DB945-8BC5-C6D8-8BA8-6D96F3E01AF3}"/>
              </a:ext>
            </a:extLst>
          </p:cNvPr>
          <p:cNvSpPr txBox="1"/>
          <p:nvPr/>
        </p:nvSpPr>
        <p:spPr>
          <a:xfrm>
            <a:off x="192993" y="2377782"/>
            <a:ext cx="3194188" cy="1815882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232 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tients on dialysis with at least one registered RAND-36 in SRR</a:t>
            </a:r>
            <a:endParaRPr lang="sv-SE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ruta 2">
            <a:extLst>
              <a:ext uri="{FF2B5EF4-FFF2-40B4-BE49-F238E27FC236}">
                <a16:creationId xmlns:a16="http://schemas.microsoft.com/office/drawing/2014/main" id="{89C593BE-5461-14D9-48D6-5393F180A9CA}"/>
              </a:ext>
            </a:extLst>
          </p:cNvPr>
          <p:cNvSpPr txBox="1"/>
          <p:nvPr/>
        </p:nvSpPr>
        <p:spPr>
          <a:xfrm>
            <a:off x="3563808" y="1733344"/>
            <a:ext cx="2355566" cy="95410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2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9 patients:</a:t>
            </a:r>
          </a:p>
          <a:p>
            <a:r>
              <a:rPr lang="en-GB" sz="2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 CSS in SRR</a:t>
            </a:r>
            <a:endParaRPr lang="sv-SE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ruta 3">
            <a:extLst>
              <a:ext uri="{FF2B5EF4-FFF2-40B4-BE49-F238E27FC236}">
                <a16:creationId xmlns:a16="http://schemas.microsoft.com/office/drawing/2014/main" id="{081F51D5-8227-8525-BF6C-13EC06C5DA35}"/>
              </a:ext>
            </a:extLst>
          </p:cNvPr>
          <p:cNvSpPr txBox="1"/>
          <p:nvPr/>
        </p:nvSpPr>
        <p:spPr>
          <a:xfrm>
            <a:off x="3650458" y="3841239"/>
            <a:ext cx="3939671" cy="181588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6 patients: </a:t>
            </a:r>
          </a:p>
          <a:p>
            <a:r>
              <a:rPr lang="en-GB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 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gistered CSS &lt; 12 months before or &gt;1.5 months after a RAND-36</a:t>
            </a:r>
            <a:endParaRPr lang="sv-SE" sz="2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ruta 4">
            <a:extLst>
              <a:ext uri="{FF2B5EF4-FFF2-40B4-BE49-F238E27FC236}">
                <a16:creationId xmlns:a16="http://schemas.microsoft.com/office/drawing/2014/main" id="{7FF5298F-9869-9705-FEC4-338E9A50B4BB}"/>
              </a:ext>
            </a:extLst>
          </p:cNvPr>
          <p:cNvSpPr txBox="1"/>
          <p:nvPr/>
        </p:nvSpPr>
        <p:spPr>
          <a:xfrm>
            <a:off x="8485160" y="2761489"/>
            <a:ext cx="3513847" cy="954107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2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137 included patients</a:t>
            </a:r>
          </a:p>
          <a:p>
            <a:r>
              <a:rPr lang="en-GB" sz="2800" dirty="0">
                <a:latin typeface="Calibri" panose="020F0502020204030204" pitchFamily="34" charset="0"/>
                <a:cs typeface="Calibri" panose="020F0502020204030204" pitchFamily="34" charset="0"/>
              </a:rPr>
              <a:t>in the total cohort</a:t>
            </a:r>
            <a:endParaRPr lang="sv-SE" sz="2800" dirty="0"/>
          </a:p>
        </p:txBody>
      </p:sp>
      <p:sp>
        <p:nvSpPr>
          <p:cNvPr id="6" name="textruta 5">
            <a:extLst>
              <a:ext uri="{FF2B5EF4-FFF2-40B4-BE49-F238E27FC236}">
                <a16:creationId xmlns:a16="http://schemas.microsoft.com/office/drawing/2014/main" id="{2C8F77A3-9981-3949-5C6E-0EEE083E93D0}"/>
              </a:ext>
            </a:extLst>
          </p:cNvPr>
          <p:cNvSpPr txBox="1"/>
          <p:nvPr/>
        </p:nvSpPr>
        <p:spPr>
          <a:xfrm>
            <a:off x="6272628" y="440682"/>
            <a:ext cx="3099766" cy="224676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sv-SE" sz="2800" dirty="0"/>
              <a:t>10 patients:</a:t>
            </a:r>
          </a:p>
          <a:p>
            <a:r>
              <a:rPr lang="sv-SE" sz="2800" dirty="0" err="1"/>
              <a:t>Missing</a:t>
            </a:r>
            <a:r>
              <a:rPr lang="sv-SE" sz="2800" dirty="0"/>
              <a:t> or </a:t>
            </a:r>
            <a:r>
              <a:rPr lang="sv-SE" sz="2800" dirty="0" err="1"/>
              <a:t>change</a:t>
            </a:r>
            <a:r>
              <a:rPr lang="sv-SE" sz="2800" dirty="0"/>
              <a:t> in </a:t>
            </a:r>
            <a:r>
              <a:rPr lang="sv-SE" sz="2800" dirty="0" err="1"/>
              <a:t>dialysis</a:t>
            </a:r>
            <a:r>
              <a:rPr lang="sv-SE" sz="2800" dirty="0"/>
              <a:t> </a:t>
            </a:r>
            <a:r>
              <a:rPr lang="sv-SE" sz="2800" dirty="0" err="1"/>
              <a:t>modality</a:t>
            </a:r>
            <a:r>
              <a:rPr lang="sv-SE" sz="2800" dirty="0"/>
              <a:t> </a:t>
            </a:r>
            <a:r>
              <a:rPr lang="sv-SE" sz="2800" dirty="0" err="1"/>
              <a:t>between</a:t>
            </a:r>
            <a:r>
              <a:rPr lang="sv-SE" sz="2800" dirty="0"/>
              <a:t> CSS and RAND-36 </a:t>
            </a:r>
          </a:p>
        </p:txBody>
      </p:sp>
      <p:cxnSp>
        <p:nvCxnSpPr>
          <p:cNvPr id="8" name="Rak pilkoppling 7">
            <a:extLst>
              <a:ext uri="{FF2B5EF4-FFF2-40B4-BE49-F238E27FC236}">
                <a16:creationId xmlns:a16="http://schemas.microsoft.com/office/drawing/2014/main" id="{B0A96628-D653-90E8-5EF7-F3AD203C3E6D}"/>
              </a:ext>
            </a:extLst>
          </p:cNvPr>
          <p:cNvCxnSpPr>
            <a:cxnSpLocks/>
          </p:cNvCxnSpPr>
          <p:nvPr/>
        </p:nvCxnSpPr>
        <p:spPr>
          <a:xfrm flipV="1">
            <a:off x="3706841" y="3285723"/>
            <a:ext cx="4563160" cy="430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Rak pilkoppling 9">
            <a:extLst>
              <a:ext uri="{FF2B5EF4-FFF2-40B4-BE49-F238E27FC236}">
                <a16:creationId xmlns:a16="http://schemas.microsoft.com/office/drawing/2014/main" id="{FD85FFE8-495D-BC50-45E3-7E188AA02BC1}"/>
              </a:ext>
            </a:extLst>
          </p:cNvPr>
          <p:cNvCxnSpPr/>
          <p:nvPr/>
        </p:nvCxnSpPr>
        <p:spPr>
          <a:xfrm flipV="1">
            <a:off x="4741591" y="2761489"/>
            <a:ext cx="0" cy="4028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Rak pilkoppling 10">
            <a:extLst>
              <a:ext uri="{FF2B5EF4-FFF2-40B4-BE49-F238E27FC236}">
                <a16:creationId xmlns:a16="http://schemas.microsoft.com/office/drawing/2014/main" id="{27C3A732-C81D-3E48-3187-0B14B6FCA1B3}"/>
              </a:ext>
            </a:extLst>
          </p:cNvPr>
          <p:cNvCxnSpPr/>
          <p:nvPr/>
        </p:nvCxnSpPr>
        <p:spPr>
          <a:xfrm flipV="1">
            <a:off x="7853407" y="2761489"/>
            <a:ext cx="0" cy="4028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Rak pilkoppling 11">
            <a:extLst>
              <a:ext uri="{FF2B5EF4-FFF2-40B4-BE49-F238E27FC236}">
                <a16:creationId xmlns:a16="http://schemas.microsoft.com/office/drawing/2014/main" id="{F16E2D88-1228-5397-8BD1-882893BD67ED}"/>
              </a:ext>
            </a:extLst>
          </p:cNvPr>
          <p:cNvCxnSpPr>
            <a:cxnSpLocks/>
          </p:cNvCxnSpPr>
          <p:nvPr/>
        </p:nvCxnSpPr>
        <p:spPr>
          <a:xfrm>
            <a:off x="5725765" y="3429000"/>
            <a:ext cx="0" cy="38964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ruta 6">
            <a:extLst>
              <a:ext uri="{FF2B5EF4-FFF2-40B4-BE49-F238E27FC236}">
                <a16:creationId xmlns:a16="http://schemas.microsoft.com/office/drawing/2014/main" id="{43E29823-47BE-36E9-70DF-B5074652F7E0}"/>
              </a:ext>
            </a:extLst>
          </p:cNvPr>
          <p:cNvSpPr txBox="1"/>
          <p:nvPr/>
        </p:nvSpPr>
        <p:spPr>
          <a:xfrm>
            <a:off x="7914372" y="4874823"/>
            <a:ext cx="4011002" cy="1384995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2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lusion of 930 </a:t>
            </a:r>
            <a:r>
              <a:rPr lang="en-GB" sz="280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tients </a:t>
            </a:r>
            <a:r>
              <a:rPr lang="en-US" sz="280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ith </a:t>
            </a:r>
            <a:r>
              <a:rPr lang="en-US" sz="2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≥ </a:t>
            </a:r>
            <a:r>
              <a:rPr lang="en-US" sz="2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wo</a:t>
            </a:r>
            <a:r>
              <a:rPr lang="en-US" sz="2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AND-36 </a:t>
            </a:r>
            <a:endParaRPr lang="en-GB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GB" sz="2800" dirty="0">
                <a:latin typeface="Calibri" panose="020F0502020204030204" pitchFamily="34" charset="0"/>
                <a:cs typeface="Calibri" panose="020F0502020204030204" pitchFamily="34" charset="0"/>
              </a:rPr>
              <a:t>Followed up to 39 months</a:t>
            </a:r>
            <a:endParaRPr lang="sv-SE" sz="2800" dirty="0"/>
          </a:p>
        </p:txBody>
      </p:sp>
      <p:cxnSp>
        <p:nvCxnSpPr>
          <p:cNvPr id="9" name="Rak pilkoppling 8">
            <a:extLst>
              <a:ext uri="{FF2B5EF4-FFF2-40B4-BE49-F238E27FC236}">
                <a16:creationId xmlns:a16="http://schemas.microsoft.com/office/drawing/2014/main" id="{B7613D69-76CC-C5FC-B7F0-BD86505B73B3}"/>
              </a:ext>
            </a:extLst>
          </p:cNvPr>
          <p:cNvCxnSpPr>
            <a:cxnSpLocks/>
          </p:cNvCxnSpPr>
          <p:nvPr/>
        </p:nvCxnSpPr>
        <p:spPr>
          <a:xfrm flipH="1">
            <a:off x="10242082" y="3841239"/>
            <a:ext cx="1240" cy="90794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83220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Breedbeeld</PresentationFormat>
  <Paragraphs>11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Helena Rydell</dc:creator>
  <cp:lastModifiedBy>Caroline Vinck - ERA</cp:lastModifiedBy>
  <cp:revision>11</cp:revision>
  <dcterms:created xsi:type="dcterms:W3CDTF">2023-08-05T14:43:15Z</dcterms:created>
  <dcterms:modified xsi:type="dcterms:W3CDTF">2024-11-20T09:00:03Z</dcterms:modified>
</cp:coreProperties>
</file>